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6" autoAdjust="0"/>
    <p:restoredTop sz="94660"/>
  </p:normalViewPr>
  <p:slideViewPr>
    <p:cSldViewPr snapToGrid="0">
      <p:cViewPr>
        <p:scale>
          <a:sx n="66" d="100"/>
          <a:sy n="66" d="100"/>
        </p:scale>
        <p:origin x="3318" y="5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51043-E5FA-4A09-9D5E-301BB528846B}" type="datetimeFigureOut">
              <a:rPr lang="ko-KR" altLang="en-US" smtClean="0"/>
              <a:t>2024-06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0DBCD-2297-4A13-8EE3-F15B4E6C9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3773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51043-E5FA-4A09-9D5E-301BB528846B}" type="datetimeFigureOut">
              <a:rPr lang="ko-KR" altLang="en-US" smtClean="0"/>
              <a:t>2024-06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0DBCD-2297-4A13-8EE3-F15B4E6C9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21271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51043-E5FA-4A09-9D5E-301BB528846B}" type="datetimeFigureOut">
              <a:rPr lang="ko-KR" altLang="en-US" smtClean="0"/>
              <a:t>2024-06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0DBCD-2297-4A13-8EE3-F15B4E6C9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87516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51043-E5FA-4A09-9D5E-301BB528846B}" type="datetimeFigureOut">
              <a:rPr lang="ko-KR" altLang="en-US" smtClean="0"/>
              <a:t>2024-06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0DBCD-2297-4A13-8EE3-F15B4E6C9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67642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51043-E5FA-4A09-9D5E-301BB528846B}" type="datetimeFigureOut">
              <a:rPr lang="ko-KR" altLang="en-US" smtClean="0"/>
              <a:t>2024-06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0DBCD-2297-4A13-8EE3-F15B4E6C9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2518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51043-E5FA-4A09-9D5E-301BB528846B}" type="datetimeFigureOut">
              <a:rPr lang="ko-KR" altLang="en-US" smtClean="0"/>
              <a:t>2024-06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0DBCD-2297-4A13-8EE3-F15B4E6C9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50347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51043-E5FA-4A09-9D5E-301BB528846B}" type="datetimeFigureOut">
              <a:rPr lang="ko-KR" altLang="en-US" smtClean="0"/>
              <a:t>2024-06-1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0DBCD-2297-4A13-8EE3-F15B4E6C9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92087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51043-E5FA-4A09-9D5E-301BB528846B}" type="datetimeFigureOut">
              <a:rPr lang="ko-KR" altLang="en-US" smtClean="0"/>
              <a:t>2024-06-1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0DBCD-2297-4A13-8EE3-F15B4E6C9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7733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51043-E5FA-4A09-9D5E-301BB528846B}" type="datetimeFigureOut">
              <a:rPr lang="ko-KR" altLang="en-US" smtClean="0"/>
              <a:t>2024-06-1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0DBCD-2297-4A13-8EE3-F15B4E6C9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40609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51043-E5FA-4A09-9D5E-301BB528846B}" type="datetimeFigureOut">
              <a:rPr lang="ko-KR" altLang="en-US" smtClean="0"/>
              <a:t>2024-06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0DBCD-2297-4A13-8EE3-F15B4E6C9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69706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51043-E5FA-4A09-9D5E-301BB528846B}" type="datetimeFigureOut">
              <a:rPr lang="ko-KR" altLang="en-US" smtClean="0"/>
              <a:t>2024-06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0DBCD-2297-4A13-8EE3-F15B4E6C9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177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951043-E5FA-4A09-9D5E-301BB528846B}" type="datetimeFigureOut">
              <a:rPr lang="ko-KR" altLang="en-US" smtClean="0"/>
              <a:t>2024-06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60DBCD-2297-4A13-8EE3-F15B4E6C9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426353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2.xml"/><Relationship Id="rId4" Type="http://schemas.openxmlformats.org/officeDocument/2006/relationships/video" Target="../media/media2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LNCap v2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670254" y="2171318"/>
            <a:ext cx="2324576" cy="1113303"/>
          </a:xfrm>
          <a:prstGeom prst="rect">
            <a:avLst/>
          </a:prstGeom>
        </p:spPr>
      </p:pic>
      <p:pic>
        <p:nvPicPr>
          <p:cNvPr id="8" name="PC-3 v2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670255" y="1012884"/>
            <a:ext cx="2324576" cy="116228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C72A6AE-929A-4AE8-8D9B-BF9651E786B4}"/>
              </a:ext>
            </a:extLst>
          </p:cNvPr>
          <p:cNvSpPr txBox="1"/>
          <p:nvPr/>
        </p:nvSpPr>
        <p:spPr>
          <a:xfrm>
            <a:off x="103277" y="94420"/>
            <a:ext cx="3134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/>
              <a:t>Supplementary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 </a:t>
            </a:r>
            <a:r>
              <a:rPr lang="en-US" altLang="ko-KR" b="1" dirty="0"/>
              <a:t>Movie</a:t>
            </a:r>
            <a:endParaRPr lang="ko-KR" altLang="en-US" b="1" dirty="0"/>
          </a:p>
        </p:txBody>
      </p:sp>
      <p:grpSp>
        <p:nvGrpSpPr>
          <p:cNvPr id="7" name="그룹 6">
            <a:extLst>
              <a:ext uri="{FF2B5EF4-FFF2-40B4-BE49-F238E27FC236}">
                <a16:creationId xmlns:a16="http://schemas.microsoft.com/office/drawing/2014/main" id="{400222E7-6129-4741-9B6C-0F8783E0EC8A}"/>
              </a:ext>
            </a:extLst>
          </p:cNvPr>
          <p:cNvGrpSpPr/>
          <p:nvPr/>
        </p:nvGrpSpPr>
        <p:grpSpPr>
          <a:xfrm>
            <a:off x="671287" y="1055424"/>
            <a:ext cx="937490" cy="1331377"/>
            <a:chOff x="1054338" y="463752"/>
            <a:chExt cx="2069862" cy="3045263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0047F888-1DD7-46AB-A42E-8047825CA310}"/>
                </a:ext>
              </a:extLst>
            </p:cNvPr>
            <p:cNvSpPr txBox="1"/>
            <p:nvPr/>
          </p:nvSpPr>
          <p:spPr>
            <a:xfrm>
              <a:off x="1054339" y="463752"/>
              <a:ext cx="206986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C-3 </a:t>
              </a:r>
              <a:endParaRPr lang="ko-KR" alt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781E53E-434C-4B07-9A5A-48DF9F3D2CC0}"/>
                </a:ext>
              </a:extLst>
            </p:cNvPr>
            <p:cNvSpPr txBox="1"/>
            <p:nvPr/>
          </p:nvSpPr>
          <p:spPr>
            <a:xfrm>
              <a:off x="1054338" y="3139683"/>
              <a:ext cx="206986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NCaP </a:t>
              </a:r>
              <a:endParaRPr lang="ko-KR" alt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" name="직사각형 8"/>
          <p:cNvSpPr/>
          <p:nvPr/>
        </p:nvSpPr>
        <p:spPr>
          <a:xfrm>
            <a:off x="288609" y="3876293"/>
            <a:ext cx="541244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</a:rPr>
              <a:t>The movie shows that cells treated with EEM (exosome enriched media) were moving faster than NM (normal media; 10 % FBS, DMEM).</a:t>
            </a:r>
            <a:endParaRPr lang="ko-KR" altLang="en-US" sz="1400" dirty="0"/>
          </a:p>
        </p:txBody>
      </p:sp>
      <p:sp>
        <p:nvSpPr>
          <p:cNvPr id="10" name="직사각형 9"/>
          <p:cNvSpPr/>
          <p:nvPr/>
        </p:nvSpPr>
        <p:spPr>
          <a:xfrm>
            <a:off x="1872139" y="724472"/>
            <a:ext cx="1122691" cy="256014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" name="직사각형 10"/>
          <p:cNvSpPr/>
          <p:nvPr/>
        </p:nvSpPr>
        <p:spPr>
          <a:xfrm>
            <a:off x="1833059" y="762228"/>
            <a:ext cx="67197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</a:rPr>
              <a:t>EEM</a:t>
            </a:r>
            <a:endParaRPr lang="ko-KR" altLang="en-US" dirty="0"/>
          </a:p>
        </p:txBody>
      </p:sp>
      <p:sp>
        <p:nvSpPr>
          <p:cNvPr id="12" name="직사각형 11"/>
          <p:cNvSpPr/>
          <p:nvPr/>
        </p:nvSpPr>
        <p:spPr>
          <a:xfrm>
            <a:off x="583469" y="734110"/>
            <a:ext cx="5565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</a:rPr>
              <a:t>NM</a:t>
            </a:r>
            <a:endParaRPr lang="ko-KR" altLang="en-US" dirty="0"/>
          </a:p>
        </p:txBody>
      </p:sp>
      <p:sp>
        <p:nvSpPr>
          <p:cNvPr id="13" name="직사각형 12"/>
          <p:cNvSpPr/>
          <p:nvPr/>
        </p:nvSpPr>
        <p:spPr>
          <a:xfrm>
            <a:off x="670254" y="737048"/>
            <a:ext cx="1189949" cy="254757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794075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1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1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4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1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34</Words>
  <Application>Microsoft Office PowerPoint</Application>
  <PresentationFormat>A4 용지(210x297mm)</PresentationFormat>
  <Paragraphs>6</Paragraphs>
  <Slides>1</Slides>
  <Notes>0</Notes>
  <HiddenSlides>0</HiddenSlides>
  <MMClips>2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dmin</dc:creator>
  <cp:lastModifiedBy>연명훈</cp:lastModifiedBy>
  <cp:revision>6</cp:revision>
  <dcterms:created xsi:type="dcterms:W3CDTF">2024-04-30T04:11:44Z</dcterms:created>
  <dcterms:modified xsi:type="dcterms:W3CDTF">2024-06-12T02:13:36Z</dcterms:modified>
</cp:coreProperties>
</file>